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65" r:id="rId3"/>
    <p:sldId id="261" r:id="rId4"/>
    <p:sldId id="262" r:id="rId5"/>
    <p:sldId id="263" r:id="rId6"/>
    <p:sldId id="260" r:id="rId7"/>
    <p:sldId id="264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72"/>
    <p:restoredTop sz="94694"/>
  </p:normalViewPr>
  <p:slideViewPr>
    <p:cSldViewPr snapToGrid="0" snapToObjects="1">
      <p:cViewPr varScale="1">
        <p:scale>
          <a:sx n="101" d="100"/>
          <a:sy n="101" d="100"/>
        </p:scale>
        <p:origin x="29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2548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3896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6530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5073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6310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791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6379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6943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9807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7256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4681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45E0E-B01A-C744-9F03-91A3BA8226DA}" type="datetimeFigureOut">
              <a:rPr lang="en-US" smtClean="0"/>
              <a:t>4/30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E332F-009F-1141-A639-DBD3EF092A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2340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Relationship Id="rId9" Type="http://schemas.openxmlformats.org/officeDocument/2006/relationships/image" Target="../media/image3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95E2166-2F0B-E74A-841A-CDE9B1E74C8E}"/>
              </a:ext>
            </a:extLst>
          </p:cNvPr>
          <p:cNvSpPr txBox="1"/>
          <p:nvPr/>
        </p:nvSpPr>
        <p:spPr>
          <a:xfrm>
            <a:off x="457200" y="2979634"/>
            <a:ext cx="59436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600" b="1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Figure 1 | Effect of vagus nerve stimulation on platelet α7nAChR expression.  a, 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C57BL6/J mice received vagus nerve stimulation or sham stimulation before harvesting circulating platelets to measure percent expression of α7nAChR.  Data are presented as mean ± s.e.m. Sham (n=9) and VNS (n=8) mice per group.  p = 0.41 vs. sham.  Statistical significance was determined by unpaired two-tailed Student’s t-test.  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</a:rPr>
              <a:t>Figure represents pooled results from 2 experiments performed independently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.  </a:t>
            </a:r>
            <a:r>
              <a:rPr lang="en-US" sz="600" b="1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b,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 C57BL6/J mice received vagus nerve stimulation or sham stimulation before harvesting platelets to measure α7nAChR median expression levels.  Data are presented as mean ± s.e.m. Sham (n=14) and VNS (n=12) mice per group.  p = 0.95 vs. sham.  Statistical significance was determined by unpaired two-tailed Student’s t-test.  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</a:rPr>
              <a:t>Figure represents pooled results from 3 experiments performed independently.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  Source data are provided as a Source Data File.</a:t>
            </a:r>
            <a:endParaRPr lang="en-US" sz="600" dirty="0"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DDF5B63-062B-384A-9D3C-C53C0FBC550F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56616" y="640080"/>
            <a:ext cx="3108960" cy="22128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BBA9176-AE05-5D4F-B528-92A11665C1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2424" y="640080"/>
            <a:ext cx="3108960" cy="2211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2648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F763916-F976-E244-86CD-82B1913FEDC0}"/>
              </a:ext>
            </a:extLst>
          </p:cNvPr>
          <p:cNvSpPr txBox="1"/>
          <p:nvPr/>
        </p:nvSpPr>
        <p:spPr>
          <a:xfrm>
            <a:off x="609600" y="2862518"/>
            <a:ext cx="5005754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600" b="1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Figure 2 | Vagus nerve stimulation requires extracellular calcium to increase platelet intracellular levels.  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C57BL6/J mice received vagus nerve stimulation or sham stimulation before harvesting circulating platelets to measure basal cytosolic calcium uptake in the absence of extracellular calcium.  Data are presented as mean ± s.e.m. Sham (n=3) and VNS (n=3) mice per group.  p = 0.87 vs. sham.  Statistical significance was determined by unpaired two-tailed Student’s t-test.  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</a:rPr>
              <a:t>Figure represents results from 1 experiment</a:t>
            </a:r>
            <a:r>
              <a:rPr lang="en-US" sz="600" dirty="0"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.</a:t>
            </a:r>
            <a:r>
              <a:rPr lang="en-US" sz="600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  Source data are provided as a Source Data File.</a:t>
            </a:r>
            <a:endParaRPr lang="en-US" sz="600" dirty="0"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1B7AE29-45A3-034B-BBF7-425C9C9D4D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120" y="614133"/>
            <a:ext cx="3688080" cy="2139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2900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856BC945-9F75-644E-AB0D-0B43735BCBEA}"/>
              </a:ext>
            </a:extLst>
          </p:cNvPr>
          <p:cNvSpPr txBox="1"/>
          <p:nvPr/>
        </p:nvSpPr>
        <p:spPr>
          <a:xfrm>
            <a:off x="2331720" y="4659314"/>
            <a:ext cx="420624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3 |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ffect of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v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gus nerve stimulation on platelet expression of activated GPIIb/IIIa, phosphatidylserine, or P-selectin in wild-type mice.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57BL6/J mice received vagus nerve stimulation or sham stimulation before harvesting platelets and analysis of activated GPIIb/IIIa (JON/A) expression.  Data are presented as mean ± s.e.m. Sham (n=13) and VNS (n=13) mice per group.  p = 0.21 vs. sham.  Statistical significance was determined by unpaired two-tailed Student’s t-test.  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57BL6/J mice received vagus nerve stimulation or sham stimulation before harvesting platelets and analysis of phosphatidylserine expression.  Data are presented as mean ± s.e.m. Sham (n=13) and VNS (n=14) mice per group.  p = 0.89 vs. sham.  Statistical significance was determined by unpaired two-tailed Student’s t-test.  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.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hrombin stimulation, and analysis of activated GPIIb/IIIa (JON/A) expression.  Data are presented as mean ± s.e.m. Sham (n=9) and VNS (n=10) mice per group.  p = 0.38 vs. sham.  Statistical significance was determined by unpaired two-tailed Student’s t-test.  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d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hrombin stimulation, and analysis of phosphatidylserine expression.  Data are presented as mean ± s.e.m. Sham (n=10) and VNS (n=11) mice per group.  p = 0.13 vs. sham.  Statistical significance was determined by unpaired two-tailed Student’s t-test.  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. </a:t>
            </a:r>
            <a:endParaRPr lang="en-US" sz="5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D55419E-A9B8-1C41-9B8B-29B33338A4A4}"/>
              </a:ext>
            </a:extLst>
          </p:cNvPr>
          <p:cNvSpPr txBox="1"/>
          <p:nvPr/>
        </p:nvSpPr>
        <p:spPr>
          <a:xfrm>
            <a:off x="42248" y="5795367"/>
            <a:ext cx="667859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-selectin (CD62P) expression.  Data are presented as mean ± s.e.m. Sham (n=8) and VNS (n=11) mice per group.  p = 0.14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activated GPIIb/IIIa (JON/A) expression.  Data are presented as mean ± s.e.m. Sham (n=10) and VNS (n=10) mice per group.  p = 0.29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hosphatidylserine expression.  Data are presented as mean ± s.e.m. Sham (n=7) and VNS (n=7) mice per group.  p = 0.12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-selectin (CD62P) expression.  Data are presented as mean ± s.e.m. Sham (n=7) and VNS (n=7) mice per group.  p = 0.86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activated GPIIb/IIIa (JON/A) expression.  Data are presented as mean ± s.e.m. Sham (n=8) and VNS (n=11) mice per group.  p = 0.20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j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hosphatidylserine expression.  Data are presented as mean ± s.e.m. Sham (n=8) and VNS (n=8) mice per group.  p = 0.95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urce data are provided as a Source Data File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500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866C8E1-187D-254B-BC80-C63FBC30CB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" y="300287"/>
            <a:ext cx="2011680" cy="137097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0654482-6650-3A4B-A218-D52395D55F9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" y="1702197"/>
            <a:ext cx="2011680" cy="1371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3F90498-E806-AB43-A07E-2C4CEAE2E36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331720" y="1700817"/>
            <a:ext cx="2011680" cy="1371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CA57531-5285-F34B-B770-C56E7EA3B994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526280" y="1700817"/>
            <a:ext cx="2011680" cy="1371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93564CB-E309-1042-B576-EA162A32FC7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7160" y="3079769"/>
            <a:ext cx="2011680" cy="137299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AD8B54F-D267-A945-9390-019B72D597B0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375704" y="3081166"/>
            <a:ext cx="2011680" cy="1371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942C441-D52C-1D4C-92F8-F322F0E91B04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525836" y="3086216"/>
            <a:ext cx="2011680" cy="13716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88B7A62-A482-4C44-A122-7B717815CA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7160" y="4422636"/>
            <a:ext cx="2011680" cy="137299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170C0CF-B831-BF48-B963-F9D482329CEF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526280" y="292608"/>
            <a:ext cx="2011680" cy="13716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6AD7CE36-F99C-3B43-9821-0F6B0DC5EBC0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331720" y="292608"/>
            <a:ext cx="2011680" cy="137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57699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841039C-F526-FE4F-BB98-E70B45385D8C}"/>
              </a:ext>
            </a:extLst>
          </p:cNvPr>
          <p:cNvSpPr txBox="1"/>
          <p:nvPr/>
        </p:nvSpPr>
        <p:spPr>
          <a:xfrm>
            <a:off x="0" y="4970076"/>
            <a:ext cx="6745160" cy="14003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 | Effect of vagus nerve stimulation on platelet expression of activated GPIIb/IIIa, phosphatidylserine, or P-selectin in α7nAChR-deficient (α7KO) mice.  a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ombin stimulation, and analysis of activated GPIIb/IIIa (JON/A) expression.  Data are presented as mean ± s.e.m. Sham (n=14) and VNS (n=15) mice per group.  p = 0.56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ombin stimulation, and analysis of phosphatidylserine expression.  Data are presented as mean ± s.e.m. Sham (n=11) and VNS (n=11) mice per group.  p = 0. 66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c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-selectin (CD62P) expression.  Data are presented as mean ± s.e.m. Sham (n=11) and VNS (n=11) mice per group.  p = 0.86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activated GPIIb/IIIa (JON/A) expression.  Data are presented as mean ± s.e.m. Sham (n=14) and VNS (n=14) mice per group.  p = 0.56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hosphatidylserine expression.  Data are presented as mean ± s.e.m. Sham (n=11) and VNS (n=11) mice per group.  p = 0.83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-selectin (CD62P) expression.  Data are presented as mean ± s.e.m. Sham (n=11) and VNS (n=11) mice per group.  p = 0.95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activated GPIIb/IIIa (JON/A) expression.  Data are presented as mean ± s.e.m. Sham (n=15) and VNS (n=15) mice per group.  p = 0.89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hosphatidylserine expression.  Data are presented as mean ± s.e.m. Sham (n=11) and VNS (n=11) mice per group.  p = 0.93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Source data are provided as a Source Data File.</a:t>
            </a:r>
            <a:endParaRPr lang="en-US" sz="500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79DBC34-334A-4E41-A65A-3F613767FF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560" y="473994"/>
            <a:ext cx="2011680" cy="139001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706B215-FF8E-1646-BDDB-E6ECFD7507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0260" y="473994"/>
            <a:ext cx="2011680" cy="139001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D81F730-19B9-D248-9054-F9AAA5E4DB45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05960" y="473765"/>
            <a:ext cx="2011680" cy="138988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349C987-62FD-DB41-A38B-1FABB5E07D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8560" y="1936598"/>
            <a:ext cx="2011680" cy="139001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B69617E-FC0C-454B-9A36-13BE96595551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330260" y="1930608"/>
            <a:ext cx="2011680" cy="138988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D0E9C08-DDCD-8D42-9988-F17251AFE2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05960" y="1940558"/>
            <a:ext cx="2011680" cy="13900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1C46BB3-4760-A74E-8267-2CDDB6FF84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8560" y="3387451"/>
            <a:ext cx="2011680" cy="139001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283CF9-581B-6F45-8A36-1C3A73EF6C9E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330260" y="3387095"/>
            <a:ext cx="2011680" cy="1389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6998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1BAB397C-3CAF-0445-97F2-76BB63CB6773}"/>
              </a:ext>
            </a:extLst>
          </p:cNvPr>
          <p:cNvSpPr txBox="1"/>
          <p:nvPr/>
        </p:nvSpPr>
        <p:spPr>
          <a:xfrm>
            <a:off x="0" y="4972410"/>
            <a:ext cx="6740769" cy="15542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 | Effect of vagus nerve stimulation on platelet expression of activated GPIIb/IIIa, phosphatidylserine, or P-selectin in athymic nude (Foxn1</a:t>
            </a:r>
            <a:r>
              <a:rPr lang="en-US" sz="5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.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ombin stimulation, and analysis of P-selectin (CD62P) expression.  Data are presented as mean ± s.e.m. Sham (n=4) and VNS (n=4) mice per group.  p = 0.88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ombin stimulation, and analysis of activated GPIIb/IIIa (JON/A) expression.  Data are presented as mean ± s.e.m. Sham (n=7) and VNS (n=7) mice per group.  p &gt; 0.99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ombin stimulation, and analysis of phosphatidylserine expression.  Data are presented as mean ± s.e.m. Sham (n=4) and VNS (n=4) mice per group.  p = 0.73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-selectin (CD62P) expression.  Data are presented as mean ± s.e.m. Sham (n=4) and VNS (n=4) mice per group.  p = 0.41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activated GPIIb/IIIa (JON/A) expression.  Data are presented as mean ± s.e.m. Sham (n=4) and VNS (n=4) mice per group.  p = 0.33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,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P stimulation, and analysis of phosphatidylserine expression.  Data are presented as mean ± s.e.m. Sham (n=4) and VNS (n=4) mice per group.  p = 0.27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-selectin (CD62P) expression.  Data are presented as mean ± s.e.m. Sham (n=4) and VNS (n=4) mice per group).  p = 0.61 vs. sham.  Statistical significance was determined by unpaired two-tailed Student’s t-test.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,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activated GPIIb/IIIa (JON/A) expression.  Data are presented as mean ± s.e.m. Sham (n=8) and VNS (n=8) mice per group.  p = 0.10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3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,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received vagus nerve stimulation or sham stimulation before harvesting platelets, </a:t>
            </a:r>
            <a:r>
              <a:rPr lang="en-US" sz="5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gen stimulation, and analysis of phosphatidylserine expression.  Data are presented as mean ± s.e.m. Sham (n=4) and VNS (n=4) mice per group).  p = 0.59 vs. sham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urce data are provided as a Source Data File.</a:t>
            </a:r>
            <a:endParaRPr lang="en-US" sz="500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F438E27-C25F-1A45-A118-5937B0339E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895" y="431465"/>
            <a:ext cx="2011680" cy="139001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7BDD13F-2345-674E-B519-D2D8758604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6175" y="434016"/>
            <a:ext cx="2011680" cy="139001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33C5C02-6F25-A349-B926-C61DB4C7CC05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10707" y="434016"/>
            <a:ext cx="2011680" cy="138988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0DDC21B-FCC7-C44D-BD8E-4C6FBEBF0E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2895" y="1928676"/>
            <a:ext cx="2011680" cy="139001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ACF04EC-7C93-BC47-B263-D8AE8834CB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26175" y="1925405"/>
            <a:ext cx="2011680" cy="13900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82EE20C-3049-D64B-AE34-D3770E271BDC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510707" y="1925405"/>
            <a:ext cx="2011680" cy="138988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11B27E7-65E8-8945-8CCC-DC7809660B53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12895" y="3469750"/>
            <a:ext cx="2011680" cy="138988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3D6BED1-EB80-5F44-BF9F-2E1274A8F8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26175" y="3469238"/>
            <a:ext cx="2011680" cy="139001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59BE5595-7972-4147-BC54-BB491505D517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510707" y="3469238"/>
            <a:ext cx="2011680" cy="1389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802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BF19809-B3C4-4C4C-83CD-9A422EF255F4}"/>
              </a:ext>
            </a:extLst>
          </p:cNvPr>
          <p:cNvSpPr txBox="1"/>
          <p:nvPr/>
        </p:nvSpPr>
        <p:spPr>
          <a:xfrm>
            <a:off x="50800" y="5049934"/>
            <a:ext cx="6755792" cy="12464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6 | Vagus nerve stimulation does not change heart rate, systemic blood pressure or regional blood flow.  a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underwent baseline heart rate measurement before and five minutes after vagus nerve stimulation.  Data are presented as mean ± s.e.m. Pre-VNS (n=6) and Post-VNS (n=6) mice per group.  p = 0.15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underwent baseline mean arterial blood pressure measurement before and five minutes after vagus nerve stimulation.  Data are presented as mean ± s.e.m. Pre-VNS (n=6) and Post-VNS (n=6) mice per group.  p = 0.73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underwent baseline heart rate measurement before and five minutes after vagus nerve stimulation.  Data are presented as mean ± s.e.m. Pre-VNS (n=5) and Post-VNS (n=4) mice per group.  p = 0.77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7nAChR-deficient (α7KO) mice underwent baseline mean arterial blood pressure measurement before and five minutes after vagus nerve stimulation.  Data are presented as mean ± s.e.m. Pre-VNS (n=5) and Post-VNS (n=4) mice per group.  p = 0.46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underwent baseline heart rate measurement before and five minutes after vagus nerve stimulation.  Data are presented as mean ± s.e.m. Pre-VNS (n=4) and Post-VNS (n=4) mice per group.  p = 0.44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hymic nude (Foxn1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underwent baseline mean arterial blood pressure measurement before and five minutes after vagus nerve stimulation.  Data are presented as mean ± s.e.m. Pre-VNS (n=4) and Post-VNS (n=4) mice per group.  p = 0.85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6g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underwent baseline tail blood flow measurement before and five minutes after vagus nerve stimulation.  Data are presented as mean ± s.e.m. Pre-VNS (n=6) and Post-VNS (n=6) mice per group.  p = 0.29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5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6h,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57BL6/J mice underwent baseline tail blood volume measurement before and five minutes after vagus nerve stimulation.  Data are presented as mean ± s.e.m. Pre-VNS (n=6) and Post-VNS (n=6) mice per group.  p = 0.57 vs. baseline.  Statistical significance was determined by unpaired two-tailed Student’s t-test. 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</a:t>
            </a:r>
            <a:r>
              <a:rPr lang="en-US" sz="500" dirty="0">
                <a:latin typeface="Arial" panose="020B0604020202020204" pitchFamily="34" charset="0"/>
                <a:ea typeface="Times New Roman" panose="02020603050405020304" pitchFamily="18" charset="0"/>
              </a:rPr>
              <a:t>e 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s pooled results from 2 experiments performed independently</a:t>
            </a:r>
            <a:r>
              <a:rPr lang="en-US" sz="5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Source data are provided as a Source Data File.</a:t>
            </a:r>
            <a:endParaRPr lang="en-US" sz="500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5E4B515-22CE-8B4F-B6D4-27D5ACF980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245" y="417491"/>
            <a:ext cx="2194560" cy="146795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4E45FAC-2968-4745-95CA-76937ED742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2197" y="414163"/>
            <a:ext cx="2194560" cy="147290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D47C9F5-3AF3-3646-88FB-A28ED3E88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245" y="1910927"/>
            <a:ext cx="2194560" cy="146793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CF2EC97-A2DB-954D-AD47-37D72C9A0E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15135" y="1908468"/>
            <a:ext cx="2194560" cy="147039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3D6450A-CD54-7A4B-9BEE-67BBA09E910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2197" y="1905997"/>
            <a:ext cx="2194560" cy="147533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2D7E954-0F41-1747-B4CF-1C403C7F61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245" y="3436827"/>
            <a:ext cx="2194560" cy="148031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3A7A236-5F7E-E041-BBE0-C1332899626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5135" y="3416960"/>
            <a:ext cx="2194560" cy="149680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4874388-D51E-884A-B458-2E09F2E365B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15135" y="411480"/>
            <a:ext cx="2194560" cy="14618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58039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995C449-2AD5-4848-8CE1-E0A23187A3C4}"/>
              </a:ext>
            </a:extLst>
          </p:cNvPr>
          <p:cNvSpPr txBox="1"/>
          <p:nvPr/>
        </p:nvSpPr>
        <p:spPr>
          <a:xfrm>
            <a:off x="609600" y="3319254"/>
            <a:ext cx="539261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7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7 | Platelet gating strategy for flow cytometry.  a,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eliminary FSC/SSC gates for sorting platelet cell population from murine systemic whole blood.  </a:t>
            </a:r>
            <a:r>
              <a:rPr lang="en-US" sz="7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latelet cell population identification with anti-CD41a.</a:t>
            </a:r>
            <a:endParaRPr lang="en-US" sz="700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94D4C6F-6AF6-5F4D-B2EC-F4421BC25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608" y="332499"/>
            <a:ext cx="2743200" cy="290029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90F714A-1A76-7B4D-AC72-F101931A83DE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134458" y="333322"/>
            <a:ext cx="2743200" cy="2898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644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4</TotalTime>
  <Words>3481</Words>
  <Application>Microsoft Macintosh PowerPoint</Application>
  <PresentationFormat>Letter Paper (8.5x11 in)</PresentationFormat>
  <Paragraphs>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ton, Tara Lynn</dc:creator>
  <cp:lastModifiedBy>Huston, Tara Lynn</cp:lastModifiedBy>
  <cp:revision>17</cp:revision>
  <dcterms:created xsi:type="dcterms:W3CDTF">2023-04-23T19:46:23Z</dcterms:created>
  <dcterms:modified xsi:type="dcterms:W3CDTF">2023-04-30T16:24:19Z</dcterms:modified>
</cp:coreProperties>
</file>